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46" d="100"/>
          <a:sy n="46" d="100"/>
        </p:scale>
        <p:origin x="1444" y="4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16BD47-F96A-BB4F-4A26-2B0C3A822A3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C3D4468-716B-E838-D445-72D91BE4DF6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E42810-D8C2-A0CB-9436-48E50FA218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B9170-545C-44F8-A9D9-9B8921225B8B}" type="datetimeFigureOut">
              <a:rPr lang="en-GB" smtClean="0"/>
              <a:t>14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0043A6-1379-E363-E553-244FA5FA57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F23A23-B50C-279B-478D-50C906C5D4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FAD7F-48BF-4D38-9ED7-7F0DCBFA0E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46207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F097E3-39F8-3B83-9E28-9A29AC196E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1D5A795-D522-DA71-64B6-5AEC500D6B1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90C54B-C933-5BFE-A85F-FCE7F8BF56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B9170-545C-44F8-A9D9-9B8921225B8B}" type="datetimeFigureOut">
              <a:rPr lang="en-GB" smtClean="0"/>
              <a:t>14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57AB32-6448-95A9-784B-0C838E9D79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CBC4B4-8E07-E34A-6C2E-FEB42E484C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FAD7F-48BF-4D38-9ED7-7F0DCBFA0E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54956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0A89C3D-5CE6-EAEE-DE51-3BB9C8544F6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544DD04-5B36-9453-7B48-32330FD9DDF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30554A-B682-D8DE-81D0-1384B92C09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B9170-545C-44F8-A9D9-9B8921225B8B}" type="datetimeFigureOut">
              <a:rPr lang="en-GB" smtClean="0"/>
              <a:t>14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960451-DE5F-F78B-A507-B880F0FA35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38078A-FAB7-7B4E-FCBB-D9B748F2ED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FAD7F-48BF-4D38-9ED7-7F0DCBFA0E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81211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F66D97-F42F-BBD2-8A29-CF22D07642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E092704-FDC9-BBE8-F013-FFF9A0B9BF3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526F32-4BE5-76FB-08C4-2450825B32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B9170-545C-44F8-A9D9-9B8921225B8B}" type="datetimeFigureOut">
              <a:rPr lang="en-GB" smtClean="0"/>
              <a:t>14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1E69D2-F5EF-4EA8-D60E-09E522ECD9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0E0C23-5F90-CA91-1C82-D16C90B6BB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FAD7F-48BF-4D38-9ED7-7F0DCBFA0E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54175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622B7B-F09C-779B-2C2F-B083E4837D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B859ABA-FEA8-D157-5216-920C55CB95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82A59A-3C58-A167-A4D2-5D116554F3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B9170-545C-44F8-A9D9-9B8921225B8B}" type="datetimeFigureOut">
              <a:rPr lang="en-GB" smtClean="0"/>
              <a:t>14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F8CD09-7243-13CC-B0D0-88559D4EFC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C27098-1C7C-2D64-3821-102828399E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FAD7F-48BF-4D38-9ED7-7F0DCBFA0E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20142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8AF5D1-106E-58A5-6D56-283ECE0D59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34A8125-7C00-E7CB-FE8B-8C2FDB33CD3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187272B-B7EB-E80A-5683-757856AE15C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AFCEEF2-BDBF-4A12-19EA-A43330FA88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B9170-545C-44F8-A9D9-9B8921225B8B}" type="datetimeFigureOut">
              <a:rPr lang="en-GB" smtClean="0"/>
              <a:t>14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D239DA1-C8D7-4FD6-3B83-2BB89D4BF5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AA9085A-CD92-3F41-F99C-E471528526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FAD7F-48BF-4D38-9ED7-7F0DCBFA0E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27584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363D1D-11ED-D004-6CD6-797124A2D0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1F1BF8-8956-C199-81F6-AC620F94DF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DBEF044-9BEC-841D-56A8-E99FA110A6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B276E4E-D303-6484-388C-0A74A39CB2F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AF55792-4E9F-6855-BCF9-B123D341D9D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9541E4C-DEB7-5338-4A28-27FB9453CD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B9170-545C-44F8-A9D9-9B8921225B8B}" type="datetimeFigureOut">
              <a:rPr lang="en-GB" smtClean="0"/>
              <a:t>14/06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C682CAD-1ACF-90D6-FA55-F20D8563BF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1DAA0B8-7481-60D2-6F3E-314F711401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FAD7F-48BF-4D38-9ED7-7F0DCBFA0E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91692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B93842-4276-FD2D-6DE9-7BFAD59674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26BCB4B-12C3-BFF6-9330-A7C34AAA70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B9170-545C-44F8-A9D9-9B8921225B8B}" type="datetimeFigureOut">
              <a:rPr lang="en-GB" smtClean="0"/>
              <a:t>14/06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6A4DF2D-1E49-72FA-AC7C-5A83747542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1CBF14E-D358-AEEC-9E9B-EDEA32831F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FAD7F-48BF-4D38-9ED7-7F0DCBFA0E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5327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34267F7-975A-E56A-13A4-D9ABD450A4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B9170-545C-44F8-A9D9-9B8921225B8B}" type="datetimeFigureOut">
              <a:rPr lang="en-GB" smtClean="0"/>
              <a:t>14/06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6A01F97-F06B-8AB0-F9F5-E25C514F4A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6B5F3A2-FCAE-ECE7-9F20-6E575811D9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FAD7F-48BF-4D38-9ED7-7F0DCBFA0E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46952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59175C-2C09-4DA6-6BE1-E7E6C466B6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28AE14-7E25-0300-7B3D-18B0D86BBAE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77BAC26-D556-0881-0131-7A262D50500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F551F51-A0EA-C9F2-A524-CB034C7CA7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B9170-545C-44F8-A9D9-9B8921225B8B}" type="datetimeFigureOut">
              <a:rPr lang="en-GB" smtClean="0"/>
              <a:t>14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6370B9B-B19B-C356-B12F-5611B1D955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5CC0DCE-518E-044E-E8C6-5DF2448B4A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FAD7F-48BF-4D38-9ED7-7F0DCBFA0E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62072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E201B3-6924-D95E-3756-2533C7FA7C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E71868B-B786-32BD-3CED-404CE872221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3998BB5-F1EE-807B-0CC5-0BE0B95F087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B03994E-F499-D58E-AE79-EF1A16A8DE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B9170-545C-44F8-A9D9-9B8921225B8B}" type="datetimeFigureOut">
              <a:rPr lang="en-GB" smtClean="0"/>
              <a:t>14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4B93443-56C8-08BE-2C6A-AE7042581C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6D7712E-5951-6C89-16F5-A8AD38A8F0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FAD7F-48BF-4D38-9ED7-7F0DCBFA0E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01312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FA8C0E8-46AB-B2C4-248A-411DF1390E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5F50D96-1548-E53E-BB6D-5078204D3D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4A3295-DA0D-D261-3E3A-7E966D5C0B0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AB9170-545C-44F8-A9D9-9B8921225B8B}" type="datetimeFigureOut">
              <a:rPr lang="en-GB" smtClean="0"/>
              <a:t>14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FD779E-07A8-92A9-4370-688C7A12392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DEA702-A7CF-3103-8B14-5ADC63E9D60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1FAD7F-48BF-4D38-9ED7-7F0DCBFA0E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68491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712C71-C5B5-9C1B-5812-918D2C5D642E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/>
              <a:t>Suppl Fig 2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ADB2427-AEBC-55B3-48D0-F7D696A679BF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603924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oup 19">
            <a:extLst>
              <a:ext uri="{FF2B5EF4-FFF2-40B4-BE49-F238E27FC236}">
                <a16:creationId xmlns:a16="http://schemas.microsoft.com/office/drawing/2014/main" id="{0F98B685-85EC-33BB-24A9-0065E6371A28}"/>
              </a:ext>
            </a:extLst>
          </p:cNvPr>
          <p:cNvGrpSpPr/>
          <p:nvPr/>
        </p:nvGrpSpPr>
        <p:grpSpPr>
          <a:xfrm>
            <a:off x="3267366" y="1946990"/>
            <a:ext cx="6338806" cy="4374963"/>
            <a:chOff x="2852515" y="1874391"/>
            <a:chExt cx="6338806" cy="4374963"/>
          </a:xfrm>
        </p:grpSpPr>
        <p:sp>
          <p:nvSpPr>
            <p:cNvPr id="97" name="Rectangle 96">
              <a:extLst>
                <a:ext uri="{FF2B5EF4-FFF2-40B4-BE49-F238E27FC236}">
                  <a16:creationId xmlns:a16="http://schemas.microsoft.com/office/drawing/2014/main" id="{DD1F93D1-8EA7-4196-361F-0481916C4C94}"/>
                </a:ext>
              </a:extLst>
            </p:cNvPr>
            <p:cNvSpPr/>
            <p:nvPr/>
          </p:nvSpPr>
          <p:spPr>
            <a:xfrm>
              <a:off x="2852515" y="1874391"/>
              <a:ext cx="6338806" cy="4374963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64CEBB4B-67CF-FC50-5C92-9A1971D5320D}"/>
                </a:ext>
              </a:extLst>
            </p:cNvPr>
            <p:cNvSpPr/>
            <p:nvPr/>
          </p:nvSpPr>
          <p:spPr>
            <a:xfrm>
              <a:off x="4563240" y="5397336"/>
              <a:ext cx="508338" cy="226224"/>
            </a:xfrm>
            <a:prstGeom prst="rect">
              <a:avLst/>
            </a:prstGeom>
            <a:solidFill>
              <a:srgbClr val="FFC000"/>
            </a:solidFill>
            <a:ln w="635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F540C8A0-D69C-A6CA-DE4F-84B93FEE2B38}"/>
                </a:ext>
              </a:extLst>
            </p:cNvPr>
            <p:cNvSpPr/>
            <p:nvPr/>
          </p:nvSpPr>
          <p:spPr>
            <a:xfrm>
              <a:off x="4562023" y="4387779"/>
              <a:ext cx="510286" cy="186600"/>
            </a:xfrm>
            <a:prstGeom prst="rect">
              <a:avLst/>
            </a:prstGeom>
            <a:solidFill>
              <a:srgbClr val="92D050"/>
            </a:solidFill>
            <a:ln w="635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cxnSp>
          <p:nvCxnSpPr>
            <p:cNvPr id="11" name="Connector: Curved 10">
              <a:extLst>
                <a:ext uri="{FF2B5EF4-FFF2-40B4-BE49-F238E27FC236}">
                  <a16:creationId xmlns:a16="http://schemas.microsoft.com/office/drawing/2014/main" id="{7A5BC67F-447A-6653-5298-A9792CC27DA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077510" y="4882623"/>
              <a:ext cx="1895955" cy="521360"/>
            </a:xfrm>
            <a:prstGeom prst="curvedConnector3">
              <a:avLst/>
            </a:prstGeom>
            <a:ln>
              <a:prstDash val="sysDash"/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3" name="Connector: Curved 12">
              <a:extLst>
                <a:ext uri="{FF2B5EF4-FFF2-40B4-BE49-F238E27FC236}">
                  <a16:creationId xmlns:a16="http://schemas.microsoft.com/office/drawing/2014/main" id="{700AC81A-F5A5-4DE8-324E-B8D7572D6BA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078730" y="5397334"/>
              <a:ext cx="1900668" cy="226224"/>
            </a:xfrm>
            <a:prstGeom prst="curvedConnector3">
              <a:avLst/>
            </a:prstGeom>
            <a:ln>
              <a:prstDash val="sysDash"/>
            </a:ln>
          </p:spPr>
          <p:style>
            <a:lnRef idx="3">
              <a:schemeClr val="accent3"/>
            </a:lnRef>
            <a:fillRef idx="0">
              <a:schemeClr val="accent3"/>
            </a:fillRef>
            <a:effectRef idx="2">
              <a:schemeClr val="accent3"/>
            </a:effectRef>
            <a:fontRef idx="minor">
              <a:schemeClr val="tx1"/>
            </a:fontRef>
          </p:style>
        </p:cxn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87FF5AC0-A9ED-F81D-46A9-FE2102648062}"/>
                </a:ext>
              </a:extLst>
            </p:cNvPr>
            <p:cNvCxnSpPr>
              <a:cxnSpLocks/>
            </p:cNvCxnSpPr>
            <p:nvPr/>
          </p:nvCxnSpPr>
          <p:spPr>
            <a:xfrm>
              <a:off x="4562018" y="5623558"/>
              <a:ext cx="2924116" cy="0"/>
            </a:xfrm>
            <a:prstGeom prst="line">
              <a:avLst/>
            </a:prstGeom>
            <a:ln/>
          </p:spPr>
          <p:style>
            <a:lnRef idx="3">
              <a:schemeClr val="accent3"/>
            </a:lnRef>
            <a:fillRef idx="0">
              <a:schemeClr val="accent3"/>
            </a:fillRef>
            <a:effectRef idx="2">
              <a:schemeClr val="accent3"/>
            </a:effectRef>
            <a:fontRef idx="minor">
              <a:schemeClr val="tx1"/>
            </a:fontRef>
          </p:style>
        </p:cxn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D3581145-EB45-EF77-F749-67BB554A063A}"/>
                </a:ext>
              </a:extLst>
            </p:cNvPr>
            <p:cNvSpPr txBox="1"/>
            <p:nvPr/>
          </p:nvSpPr>
          <p:spPr>
            <a:xfrm>
              <a:off x="3296514" y="5260905"/>
              <a:ext cx="15478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Grade </a:t>
              </a:r>
              <a:r>
                <a:rPr lang="en-US" sz="1100" dirty="0" err="1"/>
                <a:t>1A</a:t>
              </a:r>
              <a:r>
                <a:rPr lang="en-US" sz="1100" dirty="0"/>
                <a:t> = 3% (2)</a:t>
              </a:r>
              <a:endParaRPr lang="en-GB" sz="1100" dirty="0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BFBCC53C-B180-030B-76D0-C48826784CAB}"/>
                </a:ext>
              </a:extLst>
            </p:cNvPr>
            <p:cNvSpPr txBox="1"/>
            <p:nvPr/>
          </p:nvSpPr>
          <p:spPr>
            <a:xfrm>
              <a:off x="3296514" y="5444185"/>
              <a:ext cx="15478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Grade 0   = 0% (0)</a:t>
              </a:r>
              <a:endParaRPr lang="en-GB" sz="1100" dirty="0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9234728C-18A7-450D-B8D1-87BBDCCC1D4F}"/>
                </a:ext>
              </a:extLst>
            </p:cNvPr>
            <p:cNvSpPr txBox="1"/>
            <p:nvPr/>
          </p:nvSpPr>
          <p:spPr>
            <a:xfrm>
              <a:off x="3310345" y="2791578"/>
              <a:ext cx="15478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Grade </a:t>
              </a:r>
              <a:r>
                <a:rPr lang="en-US" sz="1100" dirty="0" err="1"/>
                <a:t>3B</a:t>
              </a:r>
              <a:r>
                <a:rPr lang="en-US" sz="1100" dirty="0"/>
                <a:t> = 31% (18)</a:t>
              </a:r>
              <a:endParaRPr lang="en-GB" sz="1100" dirty="0"/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EB1BF615-14BF-9FDB-A42E-36F255C4C891}"/>
                </a:ext>
              </a:extLst>
            </p:cNvPr>
            <p:cNvSpPr txBox="1"/>
            <p:nvPr/>
          </p:nvSpPr>
          <p:spPr>
            <a:xfrm>
              <a:off x="3300503" y="2420181"/>
              <a:ext cx="15478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Grade </a:t>
              </a:r>
              <a:r>
                <a:rPr lang="en-US" sz="1100" dirty="0" err="1"/>
                <a:t>3C</a:t>
              </a:r>
              <a:r>
                <a:rPr lang="en-US" sz="1100" dirty="0"/>
                <a:t> = 17% (10)</a:t>
              </a:r>
              <a:endParaRPr lang="en-GB" sz="1100" dirty="0"/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0B216E61-F31C-6B0E-736B-A79E0E0F820E}"/>
                </a:ext>
              </a:extLst>
            </p:cNvPr>
            <p:cNvSpPr txBox="1"/>
            <p:nvPr/>
          </p:nvSpPr>
          <p:spPr>
            <a:xfrm>
              <a:off x="4259722" y="5752416"/>
              <a:ext cx="102870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/>
                <a:t>Initial injury</a:t>
              </a:r>
            </a:p>
            <a:p>
              <a:pPr algn="ctr"/>
              <a:r>
                <a:rPr lang="en-US" sz="1200" b="1" dirty="0"/>
                <a:t>n = 58</a:t>
              </a:r>
              <a:endParaRPr lang="en-GB" sz="1200" b="1" dirty="0"/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DEA8C2DA-D496-65D1-FC36-3D34A88B29AB}"/>
                </a:ext>
              </a:extLst>
            </p:cNvPr>
            <p:cNvSpPr txBox="1"/>
            <p:nvPr/>
          </p:nvSpPr>
          <p:spPr>
            <a:xfrm>
              <a:off x="6503870" y="5750989"/>
              <a:ext cx="154781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/>
                <a:t>Return to Play</a:t>
              </a:r>
            </a:p>
            <a:p>
              <a:pPr algn="ctr"/>
              <a:r>
                <a:rPr lang="en-US" sz="1200" b="1" dirty="0"/>
                <a:t>n = 58</a:t>
              </a:r>
              <a:endParaRPr lang="en-GB" sz="1200" b="1" dirty="0"/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4A5BCE35-D097-F059-43E5-571C29D02987}"/>
                </a:ext>
              </a:extLst>
            </p:cNvPr>
            <p:cNvSpPr txBox="1"/>
            <p:nvPr/>
          </p:nvSpPr>
          <p:spPr>
            <a:xfrm>
              <a:off x="3293174" y="5000364"/>
              <a:ext cx="15478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Grade </a:t>
              </a:r>
              <a:r>
                <a:rPr lang="en-US" sz="1100" dirty="0" err="1"/>
                <a:t>1B</a:t>
              </a:r>
              <a:r>
                <a:rPr lang="en-US" sz="1100" dirty="0"/>
                <a:t> = 14% (8)</a:t>
              </a:r>
              <a:endParaRPr lang="en-GB" sz="1100" dirty="0"/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23ECB7E9-A080-B9E1-CCCD-00A920676D6A}"/>
                </a:ext>
              </a:extLst>
            </p:cNvPr>
            <p:cNvSpPr txBox="1"/>
            <p:nvPr/>
          </p:nvSpPr>
          <p:spPr>
            <a:xfrm>
              <a:off x="3293174" y="4526729"/>
              <a:ext cx="15478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Grade </a:t>
              </a:r>
              <a:r>
                <a:rPr lang="en-US" sz="1100" dirty="0" err="1"/>
                <a:t>2A</a:t>
              </a:r>
              <a:r>
                <a:rPr lang="en-US" sz="1100" dirty="0"/>
                <a:t> = 10% (6)</a:t>
              </a:r>
              <a:endParaRPr lang="en-GB" sz="1100" dirty="0"/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F1D8B925-616C-734B-F2EB-A900CE4FFF77}"/>
                </a:ext>
              </a:extLst>
            </p:cNvPr>
            <p:cNvSpPr txBox="1"/>
            <p:nvPr/>
          </p:nvSpPr>
          <p:spPr>
            <a:xfrm>
              <a:off x="3293076" y="4304819"/>
              <a:ext cx="15478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Grade </a:t>
              </a:r>
              <a:r>
                <a:rPr lang="en-US" sz="1100" dirty="0" err="1"/>
                <a:t>2B</a:t>
              </a:r>
              <a:r>
                <a:rPr lang="en-US" sz="1100" dirty="0"/>
                <a:t> = 3% (2)</a:t>
              </a:r>
              <a:endParaRPr lang="en-GB" sz="1100" dirty="0"/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7B1801F0-4AE3-8D3A-2A27-2E6547963C0D}"/>
                </a:ext>
              </a:extLst>
            </p:cNvPr>
            <p:cNvSpPr txBox="1"/>
            <p:nvPr/>
          </p:nvSpPr>
          <p:spPr>
            <a:xfrm>
              <a:off x="3290610" y="4010581"/>
              <a:ext cx="15478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Grade </a:t>
              </a:r>
              <a:r>
                <a:rPr lang="en-US" sz="1100" dirty="0" err="1"/>
                <a:t>2C</a:t>
              </a:r>
              <a:r>
                <a:rPr lang="en-US" sz="1100" dirty="0"/>
                <a:t> = 17% (10)</a:t>
              </a:r>
              <a:endParaRPr lang="en-GB" sz="1100" dirty="0"/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08381A01-8847-4126-8EF3-A0D570CB3570}"/>
                </a:ext>
              </a:extLst>
            </p:cNvPr>
            <p:cNvSpPr txBox="1"/>
            <p:nvPr/>
          </p:nvSpPr>
          <p:spPr>
            <a:xfrm>
              <a:off x="3290610" y="3677097"/>
              <a:ext cx="15478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Grade </a:t>
              </a:r>
              <a:r>
                <a:rPr lang="en-US" sz="1100" dirty="0" err="1"/>
                <a:t>3A</a:t>
              </a:r>
              <a:r>
                <a:rPr lang="en-US" sz="1100" dirty="0"/>
                <a:t> = 3% (2)</a:t>
              </a:r>
              <a:endParaRPr lang="en-GB" sz="1100" dirty="0"/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8F01979B-7315-9942-5BF0-BE4E8542AF12}"/>
                </a:ext>
              </a:extLst>
            </p:cNvPr>
            <p:cNvSpPr/>
            <p:nvPr/>
          </p:nvSpPr>
          <p:spPr>
            <a:xfrm>
              <a:off x="4562018" y="3751042"/>
              <a:ext cx="505031" cy="281875"/>
            </a:xfrm>
            <a:prstGeom prst="rect">
              <a:avLst/>
            </a:prstGeom>
            <a:solidFill>
              <a:schemeClr val="accent4">
                <a:lumMod val="75000"/>
              </a:schemeClr>
            </a:solidFill>
            <a:ln w="635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1DE2A52A-825D-5E63-A499-9BFD06B723AF}"/>
                </a:ext>
              </a:extLst>
            </p:cNvPr>
            <p:cNvSpPr/>
            <p:nvPr/>
          </p:nvSpPr>
          <p:spPr>
            <a:xfrm>
              <a:off x="4565075" y="2481196"/>
              <a:ext cx="500029" cy="355025"/>
            </a:xfrm>
            <a:prstGeom prst="rect">
              <a:avLst/>
            </a:prstGeom>
            <a:solidFill>
              <a:srgbClr val="FF0000"/>
            </a:solidFill>
            <a:ln w="635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E4042BE2-2BD2-3117-6EF2-36ABBB1D20C8}"/>
                </a:ext>
              </a:extLst>
            </p:cNvPr>
            <p:cNvSpPr/>
            <p:nvPr/>
          </p:nvSpPr>
          <p:spPr>
            <a:xfrm>
              <a:off x="4563239" y="5087553"/>
              <a:ext cx="509071" cy="310215"/>
            </a:xfrm>
            <a:prstGeom prst="rect">
              <a:avLst/>
            </a:prstGeom>
            <a:solidFill>
              <a:schemeClr val="accent1">
                <a:lumMod val="60000"/>
                <a:lumOff val="40000"/>
              </a:schemeClr>
            </a:solidFill>
            <a:ln w="635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FD53F3B6-2253-F698-B1A1-8C6C1D97F6B1}"/>
                </a:ext>
              </a:extLst>
            </p:cNvPr>
            <p:cNvSpPr/>
            <p:nvPr/>
          </p:nvSpPr>
          <p:spPr>
            <a:xfrm>
              <a:off x="4562022" y="4574380"/>
              <a:ext cx="510287" cy="520474"/>
            </a:xfrm>
            <a:prstGeom prst="rect">
              <a:avLst/>
            </a:prstGeom>
            <a:solidFill>
              <a:srgbClr val="0070C0"/>
            </a:solidFill>
            <a:ln w="635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7" name="Rectangle 46">
              <a:extLst>
                <a:ext uri="{FF2B5EF4-FFF2-40B4-BE49-F238E27FC236}">
                  <a16:creationId xmlns:a16="http://schemas.microsoft.com/office/drawing/2014/main" id="{8CA0BEE1-5477-11A5-136B-99647C66DE2F}"/>
                </a:ext>
              </a:extLst>
            </p:cNvPr>
            <p:cNvSpPr/>
            <p:nvPr/>
          </p:nvSpPr>
          <p:spPr>
            <a:xfrm>
              <a:off x="4562019" y="4033131"/>
              <a:ext cx="507106" cy="354223"/>
            </a:xfrm>
            <a:prstGeom prst="rect">
              <a:avLst/>
            </a:prstGeom>
            <a:solidFill>
              <a:srgbClr val="00B050"/>
            </a:solidFill>
            <a:ln w="635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0" name="Rectangle 49">
              <a:extLst>
                <a:ext uri="{FF2B5EF4-FFF2-40B4-BE49-F238E27FC236}">
                  <a16:creationId xmlns:a16="http://schemas.microsoft.com/office/drawing/2014/main" id="{CC831117-65AF-B2FE-1D62-BDCF9035E58C}"/>
                </a:ext>
              </a:extLst>
            </p:cNvPr>
            <p:cNvSpPr/>
            <p:nvPr/>
          </p:nvSpPr>
          <p:spPr>
            <a:xfrm>
              <a:off x="4566525" y="2833204"/>
              <a:ext cx="498579" cy="915571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 w="635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51" name="Rectangle 50">
              <a:extLst>
                <a:ext uri="{FF2B5EF4-FFF2-40B4-BE49-F238E27FC236}">
                  <a16:creationId xmlns:a16="http://schemas.microsoft.com/office/drawing/2014/main" id="{E7429D5E-B7E3-2E16-93CA-3BB25561C1CA}"/>
                </a:ext>
              </a:extLst>
            </p:cNvPr>
            <p:cNvSpPr/>
            <p:nvPr/>
          </p:nvSpPr>
          <p:spPr>
            <a:xfrm>
              <a:off x="7000198" y="5389679"/>
              <a:ext cx="485938" cy="240472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635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2" name="Rectangle 51">
              <a:extLst>
                <a:ext uri="{FF2B5EF4-FFF2-40B4-BE49-F238E27FC236}">
                  <a16:creationId xmlns:a16="http://schemas.microsoft.com/office/drawing/2014/main" id="{2BBFE2D9-0256-B16B-C989-87D35E530B70}"/>
                </a:ext>
              </a:extLst>
            </p:cNvPr>
            <p:cNvSpPr/>
            <p:nvPr/>
          </p:nvSpPr>
          <p:spPr>
            <a:xfrm>
              <a:off x="7000194" y="3414426"/>
              <a:ext cx="485097" cy="381014"/>
            </a:xfrm>
            <a:prstGeom prst="rect">
              <a:avLst/>
            </a:prstGeom>
            <a:solidFill>
              <a:srgbClr val="92D050"/>
            </a:solidFill>
            <a:ln w="635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D8D069F1-C622-6AA1-77D5-EF315ECAF53B}"/>
                </a:ext>
              </a:extLst>
            </p:cNvPr>
            <p:cNvSpPr txBox="1"/>
            <p:nvPr/>
          </p:nvSpPr>
          <p:spPr>
            <a:xfrm>
              <a:off x="7568394" y="4204856"/>
              <a:ext cx="154781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Grade </a:t>
              </a:r>
              <a:r>
                <a:rPr lang="en-US" sz="1000" dirty="0" err="1"/>
                <a:t>1A</a:t>
              </a:r>
              <a:r>
                <a:rPr lang="en-US" sz="1000" dirty="0"/>
                <a:t> = 19% (11)</a:t>
              </a:r>
              <a:endParaRPr lang="en-GB" sz="1000" dirty="0"/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E6FCB1E6-2D94-0C1D-B6B6-1250D5D56A9E}"/>
                </a:ext>
              </a:extLst>
            </p:cNvPr>
            <p:cNvSpPr txBox="1"/>
            <p:nvPr/>
          </p:nvSpPr>
          <p:spPr>
            <a:xfrm>
              <a:off x="7564819" y="5337778"/>
              <a:ext cx="154781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Grade 0   = 5% (3)</a:t>
              </a:r>
              <a:endParaRPr lang="en-GB" sz="1000" dirty="0"/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C13889CC-0572-57A6-C4B0-A54525E48BEA}"/>
                </a:ext>
              </a:extLst>
            </p:cNvPr>
            <p:cNvSpPr txBox="1"/>
            <p:nvPr/>
          </p:nvSpPr>
          <p:spPr>
            <a:xfrm>
              <a:off x="7567344" y="2638527"/>
              <a:ext cx="154781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Grade </a:t>
              </a:r>
              <a:r>
                <a:rPr lang="en-US" sz="1000" dirty="0" err="1"/>
                <a:t>3B</a:t>
              </a:r>
              <a:r>
                <a:rPr lang="en-US" sz="1000" dirty="0"/>
                <a:t> = 12% (7)</a:t>
              </a:r>
              <a:endParaRPr lang="en-GB" sz="1000" dirty="0"/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DE3B2F0B-960D-FB13-83FD-12AC588E7E82}"/>
                </a:ext>
              </a:extLst>
            </p:cNvPr>
            <p:cNvSpPr txBox="1"/>
            <p:nvPr/>
          </p:nvSpPr>
          <p:spPr>
            <a:xfrm>
              <a:off x="7567344" y="2425385"/>
              <a:ext cx="154781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Grade </a:t>
              </a:r>
              <a:r>
                <a:rPr lang="en-US" sz="1000" dirty="0" err="1"/>
                <a:t>3C</a:t>
              </a:r>
              <a:r>
                <a:rPr lang="en-US" sz="1000" dirty="0"/>
                <a:t> = 5% (3)</a:t>
              </a:r>
              <a:endParaRPr lang="en-GB" sz="1000" dirty="0"/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9601FCC2-BC60-C206-43D5-A51063B9FB51}"/>
                </a:ext>
              </a:extLst>
            </p:cNvPr>
            <p:cNvSpPr txBox="1"/>
            <p:nvPr/>
          </p:nvSpPr>
          <p:spPr>
            <a:xfrm>
              <a:off x="7564820" y="4841332"/>
              <a:ext cx="154781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Grade </a:t>
              </a:r>
              <a:r>
                <a:rPr lang="en-US" sz="1000" dirty="0" err="1"/>
                <a:t>1B</a:t>
              </a:r>
              <a:r>
                <a:rPr lang="en-US" sz="1000" dirty="0"/>
                <a:t> = 22% (13)</a:t>
              </a:r>
              <a:endParaRPr lang="en-GB" sz="1000" dirty="0"/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8391DEE0-3123-AA2D-24DA-0A80DC1AF7CE}"/>
                </a:ext>
              </a:extLst>
            </p:cNvPr>
            <p:cNvSpPr txBox="1"/>
            <p:nvPr/>
          </p:nvSpPr>
          <p:spPr>
            <a:xfrm>
              <a:off x="7567551" y="3742564"/>
              <a:ext cx="154781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Grade </a:t>
              </a:r>
              <a:r>
                <a:rPr lang="en-US" sz="1000" dirty="0" err="1"/>
                <a:t>2A</a:t>
              </a:r>
              <a:r>
                <a:rPr lang="en-US" sz="1000" dirty="0"/>
                <a:t> = 16% (9)</a:t>
              </a:r>
              <a:endParaRPr lang="en-GB" sz="1000" dirty="0"/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EFB27277-D77A-721E-4732-583C3459925A}"/>
                </a:ext>
              </a:extLst>
            </p:cNvPr>
            <p:cNvSpPr txBox="1"/>
            <p:nvPr/>
          </p:nvSpPr>
          <p:spPr>
            <a:xfrm>
              <a:off x="7567345" y="3375925"/>
              <a:ext cx="154781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Grade </a:t>
              </a:r>
              <a:r>
                <a:rPr lang="en-US" sz="1000" dirty="0" err="1"/>
                <a:t>2B</a:t>
              </a:r>
              <a:r>
                <a:rPr lang="en-US" sz="1000" dirty="0"/>
                <a:t> = 10% (6)</a:t>
              </a:r>
              <a:endParaRPr lang="en-GB" sz="1000" dirty="0"/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6E90806C-B2B3-9FCD-6E7F-3995D308A0E5}"/>
                </a:ext>
              </a:extLst>
            </p:cNvPr>
            <p:cNvSpPr txBox="1"/>
            <p:nvPr/>
          </p:nvSpPr>
          <p:spPr>
            <a:xfrm>
              <a:off x="7567344" y="3080597"/>
              <a:ext cx="154781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Grade </a:t>
              </a:r>
              <a:r>
                <a:rPr lang="en-US" sz="1000" dirty="0" err="1"/>
                <a:t>2C</a:t>
              </a:r>
              <a:r>
                <a:rPr lang="en-US" sz="1000" dirty="0"/>
                <a:t> = 9% (5)</a:t>
              </a:r>
              <a:endParaRPr lang="en-GB" sz="1000" dirty="0"/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1CA6BAC9-436C-EC17-9020-7BB1F775B518}"/>
                </a:ext>
              </a:extLst>
            </p:cNvPr>
            <p:cNvSpPr txBox="1"/>
            <p:nvPr/>
          </p:nvSpPr>
          <p:spPr>
            <a:xfrm>
              <a:off x="7567344" y="2879479"/>
              <a:ext cx="154781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Grade </a:t>
              </a:r>
              <a:r>
                <a:rPr lang="en-US" sz="1000" dirty="0" err="1"/>
                <a:t>3A</a:t>
              </a:r>
              <a:r>
                <a:rPr lang="en-US" sz="1000" dirty="0"/>
                <a:t> = 2% (1)</a:t>
              </a:r>
              <a:endParaRPr lang="en-GB" sz="1000" dirty="0"/>
            </a:p>
          </p:txBody>
        </p:sp>
        <p:sp>
          <p:nvSpPr>
            <p:cNvPr id="63" name="Rectangle 62">
              <a:extLst>
                <a:ext uri="{FF2B5EF4-FFF2-40B4-BE49-F238E27FC236}">
                  <a16:creationId xmlns:a16="http://schemas.microsoft.com/office/drawing/2014/main" id="{914C5784-FE79-EC36-EE26-001ABB34F96D}"/>
                </a:ext>
              </a:extLst>
            </p:cNvPr>
            <p:cNvSpPr/>
            <p:nvPr/>
          </p:nvSpPr>
          <p:spPr>
            <a:xfrm>
              <a:off x="7001038" y="3023660"/>
              <a:ext cx="485096" cy="78238"/>
            </a:xfrm>
            <a:prstGeom prst="rect">
              <a:avLst/>
            </a:prstGeom>
            <a:solidFill>
              <a:schemeClr val="accent4">
                <a:lumMod val="75000"/>
              </a:schemeClr>
            </a:solidFill>
            <a:ln w="635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66" name="Rectangle 65">
              <a:extLst>
                <a:ext uri="{FF2B5EF4-FFF2-40B4-BE49-F238E27FC236}">
                  <a16:creationId xmlns:a16="http://schemas.microsoft.com/office/drawing/2014/main" id="{9B0084CE-DAF7-2CF5-396E-9D8B10C51999}"/>
                </a:ext>
              </a:extLst>
            </p:cNvPr>
            <p:cNvSpPr/>
            <p:nvPr/>
          </p:nvSpPr>
          <p:spPr>
            <a:xfrm>
              <a:off x="7000196" y="4228972"/>
              <a:ext cx="485938" cy="674656"/>
            </a:xfrm>
            <a:prstGeom prst="rect">
              <a:avLst/>
            </a:prstGeom>
            <a:solidFill>
              <a:schemeClr val="accent1">
                <a:lumMod val="60000"/>
                <a:lumOff val="40000"/>
              </a:schemeClr>
            </a:solidFill>
            <a:ln w="635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7" name="Rectangle 66">
              <a:extLst>
                <a:ext uri="{FF2B5EF4-FFF2-40B4-BE49-F238E27FC236}">
                  <a16:creationId xmlns:a16="http://schemas.microsoft.com/office/drawing/2014/main" id="{F856F9E7-F7FD-341D-301C-FB4C7EA4F8A0}"/>
                </a:ext>
              </a:extLst>
            </p:cNvPr>
            <p:cNvSpPr/>
            <p:nvPr/>
          </p:nvSpPr>
          <p:spPr>
            <a:xfrm>
              <a:off x="7000197" y="4895512"/>
              <a:ext cx="485938" cy="497209"/>
            </a:xfrm>
            <a:prstGeom prst="rect">
              <a:avLst/>
            </a:prstGeom>
            <a:solidFill>
              <a:srgbClr val="FFC000"/>
            </a:solidFill>
            <a:ln w="635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68" name="Rectangle 67">
              <a:extLst>
                <a:ext uri="{FF2B5EF4-FFF2-40B4-BE49-F238E27FC236}">
                  <a16:creationId xmlns:a16="http://schemas.microsoft.com/office/drawing/2014/main" id="{2AF3C6B2-CCD6-3C28-777B-1E8292C9A1C0}"/>
                </a:ext>
              </a:extLst>
            </p:cNvPr>
            <p:cNvSpPr/>
            <p:nvPr/>
          </p:nvSpPr>
          <p:spPr>
            <a:xfrm>
              <a:off x="7000193" y="3099761"/>
              <a:ext cx="484471" cy="318439"/>
            </a:xfrm>
            <a:prstGeom prst="rect">
              <a:avLst/>
            </a:prstGeom>
            <a:solidFill>
              <a:srgbClr val="00B050"/>
            </a:solidFill>
            <a:ln w="635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9" name="Rectangle 68">
              <a:extLst>
                <a:ext uri="{FF2B5EF4-FFF2-40B4-BE49-F238E27FC236}">
                  <a16:creationId xmlns:a16="http://schemas.microsoft.com/office/drawing/2014/main" id="{172364ED-1563-D471-CEE2-D32656176D2F}"/>
                </a:ext>
              </a:extLst>
            </p:cNvPr>
            <p:cNvSpPr/>
            <p:nvPr/>
          </p:nvSpPr>
          <p:spPr>
            <a:xfrm>
              <a:off x="7000193" y="2723776"/>
              <a:ext cx="484471" cy="299051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 w="635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70" name="Rectangle 69">
              <a:extLst>
                <a:ext uri="{FF2B5EF4-FFF2-40B4-BE49-F238E27FC236}">
                  <a16:creationId xmlns:a16="http://schemas.microsoft.com/office/drawing/2014/main" id="{F6151164-D690-F3EE-0654-21CC6CD96A09}"/>
                </a:ext>
              </a:extLst>
            </p:cNvPr>
            <p:cNvSpPr/>
            <p:nvPr/>
          </p:nvSpPr>
          <p:spPr>
            <a:xfrm>
              <a:off x="7000195" y="3794185"/>
              <a:ext cx="485939" cy="434787"/>
            </a:xfrm>
            <a:prstGeom prst="rect">
              <a:avLst/>
            </a:prstGeom>
            <a:solidFill>
              <a:srgbClr val="0070C0"/>
            </a:solidFill>
            <a:ln w="635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cxnSp>
          <p:nvCxnSpPr>
            <p:cNvPr id="73" name="Connector: Curved 72">
              <a:extLst>
                <a:ext uri="{FF2B5EF4-FFF2-40B4-BE49-F238E27FC236}">
                  <a16:creationId xmlns:a16="http://schemas.microsoft.com/office/drawing/2014/main" id="{F29A675D-4C58-DAC5-8423-1EB31075E8D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078994" y="4249016"/>
              <a:ext cx="1907839" cy="846141"/>
            </a:xfrm>
            <a:prstGeom prst="curvedConnector3">
              <a:avLst>
                <a:gd name="adj1" fmla="val 53784"/>
              </a:avLst>
            </a:prstGeom>
            <a:ln>
              <a:solidFill>
                <a:schemeClr val="accent1">
                  <a:lumMod val="40000"/>
                  <a:lumOff val="60000"/>
                </a:schemeClr>
              </a:solidFill>
              <a:prstDash val="sysDash"/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5" name="Connector: Curved 74">
              <a:extLst>
                <a:ext uri="{FF2B5EF4-FFF2-40B4-BE49-F238E27FC236}">
                  <a16:creationId xmlns:a16="http://schemas.microsoft.com/office/drawing/2014/main" id="{827C4C65-A037-7B88-006D-E1BB0F4464E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072310" y="3822118"/>
              <a:ext cx="1907839" cy="751358"/>
            </a:xfrm>
            <a:prstGeom prst="curvedConnector3">
              <a:avLst/>
            </a:prstGeom>
            <a:ln>
              <a:solidFill>
                <a:schemeClr val="accent1">
                  <a:lumMod val="75000"/>
                </a:schemeClr>
              </a:solidFill>
              <a:prstDash val="sysDash"/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8" name="Connector: Curved 77">
              <a:extLst>
                <a:ext uri="{FF2B5EF4-FFF2-40B4-BE49-F238E27FC236}">
                  <a16:creationId xmlns:a16="http://schemas.microsoft.com/office/drawing/2014/main" id="{4A0FFCD4-650D-7A56-6ADF-ADCCCB4FC33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069223" y="3428306"/>
              <a:ext cx="1917610" cy="956230"/>
            </a:xfrm>
            <a:prstGeom prst="curvedConnector3">
              <a:avLst>
                <a:gd name="adj1" fmla="val 46296"/>
              </a:avLst>
            </a:prstGeom>
            <a:ln>
              <a:solidFill>
                <a:srgbClr val="92D050"/>
              </a:solidFill>
              <a:prstDash val="sysDash"/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0" name="Connector: Curved 79">
              <a:extLst>
                <a:ext uri="{FF2B5EF4-FFF2-40B4-BE49-F238E27FC236}">
                  <a16:creationId xmlns:a16="http://schemas.microsoft.com/office/drawing/2014/main" id="{46013D31-0A42-4B45-419B-993F0129C7B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081915" y="3108855"/>
              <a:ext cx="1898234" cy="930586"/>
            </a:xfrm>
            <a:prstGeom prst="curvedConnector3">
              <a:avLst/>
            </a:prstGeom>
            <a:ln>
              <a:solidFill>
                <a:srgbClr val="00B050"/>
              </a:solidFill>
              <a:prstDash val="sysDash"/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5" name="Connector: Curved 84">
              <a:extLst>
                <a:ext uri="{FF2B5EF4-FFF2-40B4-BE49-F238E27FC236}">
                  <a16:creationId xmlns:a16="http://schemas.microsoft.com/office/drawing/2014/main" id="{7BD9D1A9-CFA8-85D3-E8AE-520E980389C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067147" y="3028335"/>
              <a:ext cx="1911789" cy="727812"/>
            </a:xfrm>
            <a:prstGeom prst="curvedConnector3">
              <a:avLst/>
            </a:prstGeom>
            <a:ln>
              <a:solidFill>
                <a:schemeClr val="accent4">
                  <a:lumMod val="75000"/>
                </a:schemeClr>
              </a:solidFill>
              <a:prstDash val="sysDash"/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7" name="Connector: Curved 86">
              <a:extLst>
                <a:ext uri="{FF2B5EF4-FFF2-40B4-BE49-F238E27FC236}">
                  <a16:creationId xmlns:a16="http://schemas.microsoft.com/office/drawing/2014/main" id="{A6D67752-D3A6-1425-66AB-3DBD0DC05B3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078730" y="2721217"/>
              <a:ext cx="1886376" cy="124293"/>
            </a:xfrm>
            <a:prstGeom prst="curvedConnector3">
              <a:avLst/>
            </a:prstGeom>
            <a:ln>
              <a:solidFill>
                <a:schemeClr val="accent6">
                  <a:lumMod val="40000"/>
                  <a:lumOff val="60000"/>
                </a:schemeClr>
              </a:solidFill>
              <a:prstDash val="sysDash"/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94" name="Straight Connector 93">
              <a:extLst>
                <a:ext uri="{FF2B5EF4-FFF2-40B4-BE49-F238E27FC236}">
                  <a16:creationId xmlns:a16="http://schemas.microsoft.com/office/drawing/2014/main" id="{0110E284-E0CE-3A42-424E-8F9979FE28B8}"/>
                </a:ext>
              </a:extLst>
            </p:cNvPr>
            <p:cNvCxnSpPr/>
            <p:nvPr/>
          </p:nvCxnSpPr>
          <p:spPr>
            <a:xfrm>
              <a:off x="5081833" y="2492568"/>
              <a:ext cx="1905000" cy="0"/>
            </a:xfrm>
            <a:prstGeom prst="line">
              <a:avLst/>
            </a:prstGeom>
            <a:ln>
              <a:solidFill>
                <a:srgbClr val="FF0000"/>
              </a:solidFill>
              <a:prstDash val="sysDash"/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0F7FDCE1-1C5D-6387-ECFC-1E83BDA86412}"/>
                </a:ext>
              </a:extLst>
            </p:cNvPr>
            <p:cNvSpPr/>
            <p:nvPr/>
          </p:nvSpPr>
          <p:spPr>
            <a:xfrm>
              <a:off x="6999256" y="2494442"/>
              <a:ext cx="485097" cy="228918"/>
            </a:xfrm>
            <a:prstGeom prst="rect">
              <a:avLst/>
            </a:prstGeom>
            <a:solidFill>
              <a:srgbClr val="FF0000"/>
            </a:solidFill>
            <a:ln w="635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33A423CF-FC82-DB82-B9E7-747CC6A9043A}"/>
              </a:ext>
            </a:extLst>
          </p:cNvPr>
          <p:cNvSpPr txBox="1"/>
          <p:nvPr/>
        </p:nvSpPr>
        <p:spPr>
          <a:xfrm>
            <a:off x="1298999" y="536047"/>
            <a:ext cx="8825661" cy="11212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2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Percentage distribution of injury grade based on 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AMIC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lassification at initial injury and 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t Return to Play</a:t>
            </a:r>
            <a:endParaRPr lang="en-GB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610518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</TotalTime>
  <Words>178</Words>
  <Application>Microsoft Office PowerPoint</Application>
  <PresentationFormat>Widescreen</PresentationFormat>
  <Paragraphs>2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Suppl Fig 2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 Fig 2</dc:title>
  <dc:creator>muhammad ikhwan zein</dc:creator>
  <cp:lastModifiedBy>muhammad ikhwan zein</cp:lastModifiedBy>
  <cp:revision>2</cp:revision>
  <dcterms:created xsi:type="dcterms:W3CDTF">2023-03-16T10:48:44Z</dcterms:created>
  <dcterms:modified xsi:type="dcterms:W3CDTF">2024-06-14T04:05:27Z</dcterms:modified>
</cp:coreProperties>
</file>